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EF3D1-1606-F38C-0171-A2BD4534EF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2D7317-4117-2FAA-3330-AC1D9AF42E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52F5E5-1D46-911D-B18A-8AE6771A4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68EDE-2EE6-34F7-CE39-6752153493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1F40DD-6D25-7F29-0A95-A35132AFC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8170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3BFB2-88E7-7BAF-52BD-D5E3F9849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3BBFB0-0827-F622-5CED-AA044B4CAA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15343-94D6-39DA-5C34-27E7DC436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E44A58-7551-5819-5BA5-01685D75B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B74FC4-DDC0-77C7-52E8-EE0CF8B6A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2891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D74974-36C6-CB87-6907-95C5B848CB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14EDF1-C2D0-B7D6-D464-36B48839BA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2B237-0ED5-49BB-18DA-C824D0C5A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566E8C-D051-FF88-D7B9-71577B488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FD1BC-9DFB-012B-3C7C-9F60740ED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9614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1B2D3-0FDC-DC5F-E6D0-4204016C37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D8A92C-D144-BCD0-7578-36FA02267A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AB9F39-7203-FD72-62CF-3F565E0C3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FBF648-F34E-0BA4-8C1D-897037B29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85D92A-B29B-8F16-D524-7AE5CEA04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685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3356A9-7102-DF0E-EECE-A19DD0808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1C5A52-4FDE-8DBC-8D15-AF29257B29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CBFF22-CED9-1C73-EC91-FFD1CB59A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C5344-60C1-F5DB-A2F3-A73457F1A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377B74-F5C1-6F73-D2AF-32119D87D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9150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82E3F-722A-138E-00B2-31CBAE3192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CFAC95-1A77-E49B-0409-1DAC1FA039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7B2833-75CB-9B7A-DF11-8EED9BDA16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648277-CFA4-CE02-C05C-5C48335D6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B351F0-C9D4-CF88-79E9-AFC9228B9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BF6584-B025-46BF-F819-6A817C071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30742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70604-EBBD-B9FF-40B8-BCA97DEB1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45236A-2F32-CED4-00C5-E3124F116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E5735F-67D3-E9B6-CC4A-EF75CFF1CB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39266D-A51D-1AA1-A394-32AF773BA0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BC1402-21B1-85E3-5C7B-19D38CC0FE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9C400C-1221-9DB9-5EB9-C401192C7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579CCB-ADD9-1467-12E2-FB134C82F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947B0C-E278-F9A4-22C6-0A6BE6646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40663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943F5B-6CD6-C545-B117-A0940B837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BBDAD4-7B53-F31F-B09E-E2E99868E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C47516-F4BC-396F-1DB3-9E542DE63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334ED1-9C46-CAD6-0C6A-469B53624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3883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CECD87-0B7C-D3ED-758C-9659FC49B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85D025-23F3-DEA8-AD55-4B7DFFFEB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628C95-5564-89A4-78EC-D9981AF8B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602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3DEBD-A556-1E2D-E379-F29C7C4E2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6D9C05-A736-DB44-65F8-40FA134453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EE2940-4B7E-66C6-F7BF-57333D441E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C733A6-BF78-1F21-3356-5AD9397A2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3B6154-159F-D190-420F-27F5C9E39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220DBC-C227-F9AA-005F-1B88F5B0A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38551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198935-0BD2-A0EB-027A-EC28636E91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ED9185-ED4B-DECD-FE63-20A9DB5365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ACB76F-5313-8E13-9D04-5FEDE87C10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022DFA-0D02-35F8-1A74-FE7B1E961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E84527-CF9E-9629-4ABA-6DB1F9FE5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B966C0-14B6-3BF3-5D9D-CD8BE69296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7903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124ED1-EB3C-C95C-77D0-D22CBC6E5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5E78D-388E-B805-1C35-553C41F85B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D45497-CAA7-A266-957B-E8A207CEB1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43DB0-6ADF-4EB9-9FBF-ACBBAEA42EF3}" type="datetimeFigureOut">
              <a:rPr lang="en-AU" smtClean="0"/>
              <a:t>15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6422D2-244C-401C-0298-C13E3FFFD6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477E87-776D-9854-054D-484EE8561F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942535-9C50-4F4B-8465-19DEFEC973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7742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EEF8729-176C-8B8A-B7A1-4E30238974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9286" y="226220"/>
            <a:ext cx="5489169" cy="56493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0B0E8C3-3D4F-5E2B-75A0-B8EC5049DF22}"/>
              </a:ext>
            </a:extLst>
          </p:cNvPr>
          <p:cNvSpPr txBox="1"/>
          <p:nvPr/>
        </p:nvSpPr>
        <p:spPr>
          <a:xfrm>
            <a:off x="270390" y="5772790"/>
            <a:ext cx="116512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Supplementary Figure 1: Sensitivity analyses reveal consistent </a:t>
            </a:r>
            <a:r>
              <a:rPr lang="en-AU" sz="1400" b="1" dirty="0" err="1"/>
              <a:t>bxy</a:t>
            </a:r>
            <a:r>
              <a:rPr lang="en-AU" sz="1400" b="1" dirty="0"/>
              <a:t> (</a:t>
            </a:r>
            <a:r>
              <a:rPr lang="en-AU" sz="1400" b="1" dirty="0" err="1"/>
              <a:t>logOR</a:t>
            </a:r>
            <a:r>
              <a:rPr lang="en-AU" sz="1400" b="1" dirty="0"/>
              <a:t>) estimates for the 33 metabolites. </a:t>
            </a:r>
            <a:r>
              <a:rPr lang="en-AU" sz="1000" dirty="0"/>
              <a:t>GSMR: generalised summary-data-based Mendelian randomization, IVW-MR: inverse-variance weighted Mendelian randomization, MR-Egger: Mendelian randomization-Egger. </a:t>
            </a:r>
          </a:p>
        </p:txBody>
      </p:sp>
    </p:spTree>
    <p:extLst>
      <p:ext uri="{BB962C8B-B14F-4D97-AF65-F5344CB8AC3E}">
        <p14:creationId xmlns:p14="http://schemas.microsoft.com/office/powerpoint/2010/main" val="363452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South Austra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Stacey</dc:creator>
  <cp:lastModifiedBy>David Stacey</cp:lastModifiedBy>
  <cp:revision>6</cp:revision>
  <dcterms:created xsi:type="dcterms:W3CDTF">2023-06-08T01:27:32Z</dcterms:created>
  <dcterms:modified xsi:type="dcterms:W3CDTF">2023-11-15T02:53:17Z</dcterms:modified>
</cp:coreProperties>
</file>